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41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1BE82C-C040-4E5B-85B0-BDCA844A192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8F26EE79-68E3-47CA-9CEF-BDEF666724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72EEFDE4-E590-4470-863C-3E46876D8801}"/>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5DF681FD-9845-402A-A346-701993F3ED6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D1C186F-661D-41F2-A653-8FCA7BDCD8CD}"/>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10015632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DE4BF1-559F-4C08-8625-29A1EDA2F074}"/>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EA4C415-9201-4549-94BE-5529C844F54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8B097A1-893F-457B-BB60-4ABFA3FB4563}"/>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1B84C841-33E4-40C5-9D39-5FA8B2D54CD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FB6388E-B157-4ECA-AD3D-D68009CAC370}"/>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3889814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170BF99-42B0-4099-8AC2-5B0FC0B5F82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28F5AFB-2BE6-40DC-81AE-546856F889C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C9E2158-32A4-4FE3-B17E-E232B943CD0F}"/>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9C3EB48C-BA28-4CD8-81BD-448AE9EF820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150E7B4-72D3-47FD-86ED-385066B0B353}"/>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1487200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D859FF-FD0E-462E-B1C8-7F9E3F54C6A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F78EA28-1215-4BCE-A569-F0E865CA86D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1757C4C-0E01-4F25-86CB-6D1883C736ED}"/>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198BBCB9-1F37-4ACD-961F-3F74F9E775A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0BCBE70-A807-4D21-8A24-246C3C9393C0}"/>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29446523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054C11-E179-4CF9-A679-A5B37EE30F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45F29F6-2A41-4417-B810-44BD03E3D0D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DFE2055-A994-4F5A-A022-C22E0CA2A5FF}"/>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162B2D7F-5CC9-44CF-A018-0F629828637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D36E8D7-E12F-4A29-84F4-474E65A39688}"/>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24746560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AFBEF-5E36-4A88-A391-21B6A2A55B2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2236CFC2-ADDF-4542-8327-09EDA5032C2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CFD2952-5DBD-4244-B0B0-D2DC2D08DD3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7E927A46-F754-414C-AB35-C5FE396306B6}"/>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6" name="Footer Placeholder 5">
            <a:extLst>
              <a:ext uri="{FF2B5EF4-FFF2-40B4-BE49-F238E27FC236}">
                <a16:creationId xmlns:a16="http://schemas.microsoft.com/office/drawing/2014/main" id="{639DEE48-78AB-4624-B076-B3D3D0B8CE4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9F913DD-8D62-4012-B3B2-E131A65DF275}"/>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9829624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6EBFA-CF4C-4C97-997F-C853A23CC822}"/>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66119BD-F2B6-49F2-8F4B-A2D251B22E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6F599E4-E316-48E8-BD1E-44923A74C9A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849896DA-CB3E-4412-933F-F707AA526F2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41BE94-6E5E-4C98-8F9D-BE5509C9A81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410F3542-2C30-467C-9746-2D3A16650484}"/>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8" name="Footer Placeholder 7">
            <a:extLst>
              <a:ext uri="{FF2B5EF4-FFF2-40B4-BE49-F238E27FC236}">
                <a16:creationId xmlns:a16="http://schemas.microsoft.com/office/drawing/2014/main" id="{5C87755E-7C15-42AB-BA1A-0ABE7C2CD540}"/>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1D387BBE-6EFE-4580-84CE-E28C84430C6A}"/>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27521828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6B56D8-983B-4D0C-9591-430850F3A5ED}"/>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4C18D9EA-02AA-4868-AE8A-239C240D1890}"/>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4" name="Footer Placeholder 3">
            <a:extLst>
              <a:ext uri="{FF2B5EF4-FFF2-40B4-BE49-F238E27FC236}">
                <a16:creationId xmlns:a16="http://schemas.microsoft.com/office/drawing/2014/main" id="{D990557B-E27E-4D3D-8AF7-694F2DD5C6C7}"/>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65F25932-DD26-45B0-881A-1BFB6E6AAA5D}"/>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36892153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DBD3137-AA6F-4580-B2DF-FA5A94D24C75}"/>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3" name="Footer Placeholder 2">
            <a:extLst>
              <a:ext uri="{FF2B5EF4-FFF2-40B4-BE49-F238E27FC236}">
                <a16:creationId xmlns:a16="http://schemas.microsoft.com/office/drawing/2014/main" id="{44E9F9FC-8FDA-4319-95AF-813E294FBBC9}"/>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E580B80-9727-4025-9DB4-6A3BE8DEC4A1}"/>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20490356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921ECE-9189-4D06-8CB1-D8A4B3DFED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F912C405-DE3D-4240-BC86-61EEEE77AEA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A8DE14B0-CA98-4E9E-AC47-E11AB863C66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F7A493-47EB-44B3-BC0F-EB48EC9AEE0C}"/>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6" name="Footer Placeholder 5">
            <a:extLst>
              <a:ext uri="{FF2B5EF4-FFF2-40B4-BE49-F238E27FC236}">
                <a16:creationId xmlns:a16="http://schemas.microsoft.com/office/drawing/2014/main" id="{B0D651B0-E537-4C3E-B900-935AA0CE52C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11B262B-6E1E-40B0-9C1C-2281F4AA7287}"/>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1485199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991F1A-ACC7-4A53-BDA3-281C712C5A6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6C3F638-6740-4D47-A082-695BB673CA4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BDE1E5D4-B938-4597-9FFE-596975D07E4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48E3197-AF2D-4112-94F9-8D462210F004}"/>
              </a:ext>
            </a:extLst>
          </p:cNvPr>
          <p:cNvSpPr>
            <a:spLocks noGrp="1"/>
          </p:cNvSpPr>
          <p:nvPr>
            <p:ph type="dt" sz="half" idx="10"/>
          </p:nvPr>
        </p:nvSpPr>
        <p:spPr/>
        <p:txBody>
          <a:bodyPr/>
          <a:lstStyle/>
          <a:p>
            <a:fld id="{066B96AC-24EC-4E6F-BEFD-E9FD42A0AABF}" type="datetimeFigureOut">
              <a:rPr lang="en-GB" smtClean="0"/>
              <a:t>16/06/2022</a:t>
            </a:fld>
            <a:endParaRPr lang="en-GB"/>
          </a:p>
        </p:txBody>
      </p:sp>
      <p:sp>
        <p:nvSpPr>
          <p:cNvPr id="6" name="Footer Placeholder 5">
            <a:extLst>
              <a:ext uri="{FF2B5EF4-FFF2-40B4-BE49-F238E27FC236}">
                <a16:creationId xmlns:a16="http://schemas.microsoft.com/office/drawing/2014/main" id="{C3DC169A-FB1A-48AA-B1A5-9D864527B04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E67D9D1-4F80-4644-8905-CF4B4CF9338F}"/>
              </a:ext>
            </a:extLst>
          </p:cNvPr>
          <p:cNvSpPr>
            <a:spLocks noGrp="1"/>
          </p:cNvSpPr>
          <p:nvPr>
            <p:ph type="sldNum" sz="quarter" idx="12"/>
          </p:nvPr>
        </p:nvSpPr>
        <p:spPr/>
        <p:txBody>
          <a:bodyPr/>
          <a:lstStyle/>
          <a:p>
            <a:fld id="{6D401824-640F-4CE3-9B40-925AA73BE380}" type="slidenum">
              <a:rPr lang="en-GB" smtClean="0"/>
              <a:t>‹#›</a:t>
            </a:fld>
            <a:endParaRPr lang="en-GB"/>
          </a:p>
        </p:txBody>
      </p:sp>
    </p:spTree>
    <p:extLst>
      <p:ext uri="{BB962C8B-B14F-4D97-AF65-F5344CB8AC3E}">
        <p14:creationId xmlns:p14="http://schemas.microsoft.com/office/powerpoint/2010/main" val="21563225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9389F52-D650-45B4-91CB-54ADB973EE3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1E6C362-FDC8-4E92-9913-87C9412365E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B275B30-0A23-4810-8642-1BED0F994CC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6B96AC-24EC-4E6F-BEFD-E9FD42A0AABF}" type="datetimeFigureOut">
              <a:rPr lang="en-GB" smtClean="0"/>
              <a:t>16/06/2022</a:t>
            </a:fld>
            <a:endParaRPr lang="en-GB"/>
          </a:p>
        </p:txBody>
      </p:sp>
      <p:sp>
        <p:nvSpPr>
          <p:cNvPr id="5" name="Footer Placeholder 4">
            <a:extLst>
              <a:ext uri="{FF2B5EF4-FFF2-40B4-BE49-F238E27FC236}">
                <a16:creationId xmlns:a16="http://schemas.microsoft.com/office/drawing/2014/main" id="{35064FC1-161C-48AA-AE16-35CEAA432AD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250BBF73-2BEE-4543-BC81-35BE0778FB8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D401824-640F-4CE3-9B40-925AA73BE380}" type="slidenum">
              <a:rPr lang="en-GB" smtClean="0"/>
              <a:t>‹#›</a:t>
            </a:fld>
            <a:endParaRPr lang="en-GB"/>
          </a:p>
        </p:txBody>
      </p:sp>
    </p:spTree>
    <p:extLst>
      <p:ext uri="{BB962C8B-B14F-4D97-AF65-F5344CB8AC3E}">
        <p14:creationId xmlns:p14="http://schemas.microsoft.com/office/powerpoint/2010/main" val="30644607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B77C16F-FC97-4D17-AC0E-0F301508E4B6}"/>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324940" y="460121"/>
            <a:ext cx="4298315" cy="4407535"/>
          </a:xfrm>
          <a:prstGeom prst="rect">
            <a:avLst/>
          </a:prstGeom>
          <a:noFill/>
        </p:spPr>
      </p:pic>
      <p:sp>
        <p:nvSpPr>
          <p:cNvPr id="6" name="TextBox 5">
            <a:extLst>
              <a:ext uri="{FF2B5EF4-FFF2-40B4-BE49-F238E27FC236}">
                <a16:creationId xmlns:a16="http://schemas.microsoft.com/office/drawing/2014/main" id="{0CD77618-5DEC-47BA-B155-965520A16F20}"/>
              </a:ext>
            </a:extLst>
          </p:cNvPr>
          <p:cNvSpPr txBox="1"/>
          <p:nvPr/>
        </p:nvSpPr>
        <p:spPr>
          <a:xfrm>
            <a:off x="1052198" y="4867656"/>
            <a:ext cx="6097554" cy="1754326"/>
          </a:xfrm>
          <a:prstGeom prst="rect">
            <a:avLst/>
          </a:prstGeom>
          <a:noFill/>
        </p:spPr>
        <p:txBody>
          <a:bodyPr wrap="square">
            <a:spAutoFit/>
          </a:bodyPr>
          <a:lstStyle/>
          <a:p>
            <a:r>
              <a:rPr lang="en-GB" sz="1200" b="1" kern="1200" dirty="0">
                <a:solidFill>
                  <a:srgbClr val="000000"/>
                </a:solidFill>
                <a:effectLst/>
                <a:latin typeface="Times New Roman" panose="02020603050405020304" pitchFamily="18" charset="0"/>
                <a:ea typeface="Times New Roman" panose="02020603050405020304" pitchFamily="18" charset="0"/>
              </a:rPr>
              <a:t>Figure S1 – Baseline expression of IMRs in peripheral blood mononuclear cells from healthy and severe asthmatic donors.  </a:t>
            </a:r>
            <a:r>
              <a:rPr lang="en-GB" sz="1200" kern="1200" dirty="0">
                <a:solidFill>
                  <a:srgbClr val="000000"/>
                </a:solidFill>
                <a:effectLst/>
                <a:latin typeface="Times New Roman" panose="02020603050405020304" pitchFamily="18" charset="0"/>
                <a:ea typeface="Times New Roman" panose="02020603050405020304" pitchFamily="18" charset="0"/>
              </a:rPr>
              <a:t>A) PBMCs were stained with an antibody panel to identify four subtypes using a sequential gating strategy (i size, ii CD3+ to identify lymphocytes, iii CD3+ cells were stained with CD4 and CD8 to identify Th and Tc cells respectively, iv CD3- cells were stained with CD14 and CD56 to identify monocytes and NK cells respectively.   These cell populations were further examined for cell surface expression of the GITR, LIGHT, HVEM and BTLA IMRs by extracellular staining using monoclonal antibodies conjugated to PE.  Data shown are individual data points with medians +/- IQR and were compared using Mann-Whitney tests. N=10 per group.</a:t>
            </a:r>
            <a:endParaRPr lang="en-GB"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7886734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36</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jamin Nicholas</dc:creator>
  <cp:lastModifiedBy>Benjamin Nicholas</cp:lastModifiedBy>
  <cp:revision>1</cp:revision>
  <dcterms:created xsi:type="dcterms:W3CDTF">2022-06-16T07:49:47Z</dcterms:created>
  <dcterms:modified xsi:type="dcterms:W3CDTF">2022-06-16T07:50:34Z</dcterms:modified>
</cp:coreProperties>
</file>